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82" r:id="rId3"/>
    <p:sldId id="273" r:id="rId4"/>
    <p:sldId id="274" r:id="rId5"/>
    <p:sldId id="275" r:id="rId6"/>
    <p:sldId id="276" r:id="rId7"/>
    <p:sldId id="277" r:id="rId8"/>
    <p:sldId id="278" r:id="rId9"/>
    <p:sldId id="259" r:id="rId10"/>
    <p:sldId id="279" r:id="rId11"/>
    <p:sldId id="281" r:id="rId12"/>
    <p:sldId id="280" r:id="rId13"/>
    <p:sldId id="263" r:id="rId14"/>
    <p:sldId id="264" r:id="rId15"/>
    <p:sldId id="265" r:id="rId16"/>
    <p:sldId id="266" r:id="rId17"/>
    <p:sldId id="268" r:id="rId18"/>
    <p:sldId id="269" r:id="rId19"/>
    <p:sldId id="270" r:id="rId20"/>
    <p:sldId id="267" r:id="rId21"/>
    <p:sldId id="258" r:id="rId22"/>
    <p:sldId id="257" r:id="rId23"/>
    <p:sldId id="256" r:id="rId2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048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147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904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810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245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019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930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96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199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244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7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6BEBB-3E91-43F5-94DB-A17C723B6CC6}" type="datetimeFigureOut">
              <a:rPr lang="en-US" smtClean="0"/>
              <a:t>12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3A508-F1A2-4951-9666-66F9E6403C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288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91630" y="1445490"/>
            <a:ext cx="53719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uman Chromosomes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1-20, 22 and X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905000" y="2373868"/>
            <a:ext cx="4563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ocation </a:t>
            </a:r>
            <a:r>
              <a:rPr lang="en-US" smtClean="0"/>
              <a:t>of INR </a:t>
            </a:r>
            <a:r>
              <a:rPr lang="en-US" dirty="0" smtClean="0"/>
              <a:t>Elements in the Core Promot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50724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77850"/>
            <a:ext cx="5411787" cy="5705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33686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39750"/>
            <a:ext cx="5327650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01697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4038"/>
            <a:ext cx="5411787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7052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16417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44513"/>
            <a:ext cx="5327650" cy="5773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6601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54038"/>
            <a:ext cx="5327650" cy="5753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49531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49275"/>
            <a:ext cx="5327650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34658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82613"/>
            <a:ext cx="5413375" cy="5695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8189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1787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104797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30225"/>
            <a:ext cx="5327650" cy="5800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3626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68325"/>
            <a:ext cx="5411787" cy="572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5760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3413" y="549275"/>
            <a:ext cx="5337175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27399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1787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396968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175" y="520700"/>
            <a:ext cx="5327650" cy="5819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9020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38934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411163"/>
            <a:ext cx="5413375" cy="6040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76395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0700"/>
            <a:ext cx="5411787" cy="5819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42433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037633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52450"/>
            <a:ext cx="5413375" cy="5757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07208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7250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5463"/>
            <a:ext cx="5413375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1967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20700"/>
            <a:ext cx="5411787" cy="5819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80701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15</Words>
  <Application>Microsoft Office PowerPoint</Application>
  <PresentationFormat>On-screen Show (4:3)</PresentationFormat>
  <Paragraphs>2</Paragraphs>
  <Slides>2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 Brown</dc:creator>
  <cp:lastModifiedBy>Jay Brown</cp:lastModifiedBy>
  <cp:revision>61</cp:revision>
  <dcterms:created xsi:type="dcterms:W3CDTF">2017-10-03T14:43:58Z</dcterms:created>
  <dcterms:modified xsi:type="dcterms:W3CDTF">2017-12-10T16:17:08Z</dcterms:modified>
</cp:coreProperties>
</file>